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6" roundtripDataSignature="AMtx7mhusbwWdUDMSGks3y82v1MMgZSMu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33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customschemas.google.com/relationships/presentationmetadata" Target="metadata"/><Relationship Id="rId10" Type="http://schemas.openxmlformats.org/officeDocument/2006/relationships/tableStyles" Target="tableStyles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I:\DI\Art&#237;culos\RNAseq%20EIN1%20EIN4\Paper%20RNAseq%20transicion%20floral\Validac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I:\DI\Art&#237;culos\RNAseq%20EIN1%20EIN4\Paper%20RNAseq%20transicion%20floral\Validac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2559184807781379E-2"/>
          <c:y val="5.0925925925925923E-2"/>
          <c:w val="0.96708787401574803"/>
          <c:h val="0.796296296296296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EIN1 (2)'!$C$2</c:f>
              <c:strCache>
                <c:ptCount val="1"/>
                <c:pt idx="0">
                  <c:v>RNA-seq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C00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CB7-4BFF-B917-84B26A319889}"/>
              </c:ext>
            </c:extLst>
          </c:dPt>
          <c:dPt>
            <c:idx val="1"/>
            <c:invertIfNegative val="0"/>
            <c:bubble3D val="0"/>
            <c:spPr>
              <a:solidFill>
                <a:srgbClr val="00CC3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CB7-4BFF-B917-84B26A319889}"/>
              </c:ext>
            </c:extLst>
          </c:dPt>
          <c:dPt>
            <c:idx val="2"/>
            <c:invertIfNegative val="0"/>
            <c:bubble3D val="0"/>
            <c:spPr>
              <a:solidFill>
                <a:srgbClr val="CC00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CB7-4BFF-B917-84B26A319889}"/>
              </c:ext>
            </c:extLst>
          </c:dPt>
          <c:dPt>
            <c:idx val="3"/>
            <c:invertIfNegative val="0"/>
            <c:bubble3D val="0"/>
            <c:spPr>
              <a:solidFill>
                <a:srgbClr val="00CC3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BCB7-4BFF-B917-84B26A319889}"/>
              </c:ext>
            </c:extLst>
          </c:dPt>
          <c:dPt>
            <c:idx val="4"/>
            <c:invertIfNegative val="0"/>
            <c:bubble3D val="0"/>
            <c:spPr>
              <a:solidFill>
                <a:srgbClr val="CC00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BCB7-4BFF-B917-84B26A319889}"/>
              </c:ext>
            </c:extLst>
          </c:dPt>
          <c:dPt>
            <c:idx val="5"/>
            <c:invertIfNegative val="0"/>
            <c:bubble3D val="0"/>
            <c:spPr>
              <a:solidFill>
                <a:srgbClr val="00CC3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BCB7-4BFF-B917-84B26A319889}"/>
              </c:ext>
            </c:extLst>
          </c:dPt>
          <c:dPt>
            <c:idx val="6"/>
            <c:invertIfNegative val="0"/>
            <c:bubble3D val="0"/>
            <c:spPr>
              <a:solidFill>
                <a:srgbClr val="CC00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BCB7-4BFF-B917-84B26A319889}"/>
              </c:ext>
            </c:extLst>
          </c:dPt>
          <c:dPt>
            <c:idx val="7"/>
            <c:invertIfNegative val="0"/>
            <c:bubble3D val="0"/>
            <c:spPr>
              <a:solidFill>
                <a:srgbClr val="00CC3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BCB7-4BFF-B917-84B26A319889}"/>
              </c:ext>
            </c:extLst>
          </c:dPt>
          <c:dPt>
            <c:idx val="8"/>
            <c:invertIfNegative val="0"/>
            <c:bubble3D val="0"/>
            <c:spPr>
              <a:solidFill>
                <a:srgbClr val="CC009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BCB7-4BFF-B917-84B26A319889}"/>
              </c:ext>
            </c:extLst>
          </c:dPt>
          <c:dPt>
            <c:idx val="9"/>
            <c:invertIfNegative val="0"/>
            <c:bubble3D val="0"/>
            <c:spPr>
              <a:solidFill>
                <a:srgbClr val="00CC33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BCB7-4BFF-B917-84B26A319889}"/>
              </c:ext>
            </c:extLst>
          </c:dPt>
          <c:errBars>
            <c:errBarType val="both"/>
            <c:errValType val="cust"/>
            <c:noEndCap val="0"/>
            <c:plus>
              <c:numRef>
                <c:f>('EIN1 (2)'!$E$61:$E$64,'EIN1 (2)'!$E$67:$E$72)</c:f>
                <c:numCache>
                  <c:formatCode>General</c:formatCode>
                  <c:ptCount val="10"/>
                  <c:pt idx="0">
                    <c:v>0.21309176851560574</c:v>
                  </c:pt>
                  <c:pt idx="1">
                    <c:v>0.25830934436190078</c:v>
                  </c:pt>
                  <c:pt idx="2">
                    <c:v>0.22695308833294939</c:v>
                  </c:pt>
                  <c:pt idx="3">
                    <c:v>0.23880406124966241</c:v>
                  </c:pt>
                  <c:pt idx="4">
                    <c:v>0.15416442437979702</c:v>
                  </c:pt>
                  <c:pt idx="5">
                    <c:v>0.14457540632548138</c:v>
                  </c:pt>
                  <c:pt idx="6">
                    <c:v>0.38511997652537028</c:v>
                  </c:pt>
                  <c:pt idx="7">
                    <c:v>0.87004204962481546</c:v>
                  </c:pt>
                  <c:pt idx="8">
                    <c:v>0.29183754352321045</c:v>
                  </c:pt>
                  <c:pt idx="9">
                    <c:v>0.29892825388761762</c:v>
                  </c:pt>
                </c:numCache>
                <c:extLst/>
              </c:numRef>
            </c:plus>
            <c:minus>
              <c:numRef>
                <c:f>('EIN1 (2)'!$E$61:$E$64,'EIN1 (2)'!$E$67:$E$72)</c:f>
                <c:numCache>
                  <c:formatCode>General</c:formatCode>
                  <c:ptCount val="10"/>
                  <c:pt idx="0">
                    <c:v>0.21309176851560574</c:v>
                  </c:pt>
                  <c:pt idx="1">
                    <c:v>0.25830934436190078</c:v>
                  </c:pt>
                  <c:pt idx="2">
                    <c:v>0.22695308833294939</c:v>
                  </c:pt>
                  <c:pt idx="3">
                    <c:v>0.23880406124966241</c:v>
                  </c:pt>
                  <c:pt idx="4">
                    <c:v>0.15416442437979702</c:v>
                  </c:pt>
                  <c:pt idx="5">
                    <c:v>0.14457540632548138</c:v>
                  </c:pt>
                  <c:pt idx="6">
                    <c:v>0.38511997652537028</c:v>
                  </c:pt>
                  <c:pt idx="7">
                    <c:v>0.87004204962481546</c:v>
                  </c:pt>
                  <c:pt idx="8">
                    <c:v>0.29183754352321045</c:v>
                  </c:pt>
                  <c:pt idx="9">
                    <c:v>0.2989282538876176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EIN1 (2)'!$A$5:$A$6,'EIN1 (2)'!$A$11:$A$12,'EIN1 (2)'!$A$23:$A$24,'EIN1 (2)'!$A$29:$A$30,'EIN1 (2)'!$A$35:$A$36)</c:f>
              <c:strCache>
                <c:ptCount val="9"/>
                <c:pt idx="0">
                  <c:v>CpACS27</c:v>
                </c:pt>
                <c:pt idx="2">
                  <c:v>CpACS11</c:v>
                </c:pt>
                <c:pt idx="4">
                  <c:v>CpACO2</c:v>
                </c:pt>
                <c:pt idx="6">
                  <c:v>CpETR1A</c:v>
                </c:pt>
                <c:pt idx="8">
                  <c:v>CpETR1B</c:v>
                </c:pt>
              </c:strCache>
              <c:extLst/>
            </c:strRef>
          </c:cat>
          <c:val>
            <c:numRef>
              <c:f>('EIN1 (2)'!$C$5:$C$6,'EIN1 (2)'!$C$11:$C$12,'EIN1 (2)'!$C$23:$C$24,'EIN1 (2)'!$C$29:$C$30,'EIN1 (2)'!$C$35:$C$36)</c:f>
              <c:numCache>
                <c:formatCode>General</c:formatCode>
                <c:ptCount val="10"/>
                <c:pt idx="0">
                  <c:v>5.2100007140059104</c:v>
                </c:pt>
                <c:pt idx="1">
                  <c:v>7.1621553194839196</c:v>
                </c:pt>
                <c:pt idx="2">
                  <c:v>8.6990391708771906</c:v>
                </c:pt>
                <c:pt idx="3">
                  <c:v>6.0576962494249802</c:v>
                </c:pt>
                <c:pt idx="4">
                  <c:v>1.4015698040812199</c:v>
                </c:pt>
                <c:pt idx="5">
                  <c:v>1.5980133966591299</c:v>
                </c:pt>
                <c:pt idx="6">
                  <c:v>0.25706822707766602</c:v>
                </c:pt>
                <c:pt idx="7">
                  <c:v>0.113360716450782</c:v>
                </c:pt>
                <c:pt idx="8">
                  <c:v>0.35435252668612</c:v>
                </c:pt>
                <c:pt idx="9">
                  <c:v>0.35054193630689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BCB7-4BFF-B917-84B26A319889}"/>
            </c:ext>
          </c:extLst>
        </c:ser>
        <c:ser>
          <c:idx val="1"/>
          <c:order val="1"/>
          <c:tx>
            <c:strRef>
              <c:f>'EIN1 (2)'!$D$2</c:f>
              <c:strCache>
                <c:ptCount val="1"/>
                <c:pt idx="0">
                  <c:v>(qRT)-PCR</c:v>
                </c:pt>
              </c:strCache>
            </c:strRef>
          </c:tx>
          <c:spPr>
            <a:pattFill prst="dkDnDiag">
              <a:fgClr>
                <a:schemeClr val="accent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kDnDiag">
                <a:fgClr>
                  <a:srgbClr val="CC0099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6-BCB7-4BFF-B917-84B26A319889}"/>
              </c:ext>
            </c:extLst>
          </c:dPt>
          <c:dPt>
            <c:idx val="1"/>
            <c:invertIfNegative val="0"/>
            <c:bubble3D val="0"/>
            <c:spPr>
              <a:pattFill prst="dkDnDiag">
                <a:fgClr>
                  <a:srgbClr val="00CC33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8-BCB7-4BFF-B917-84B26A319889}"/>
              </c:ext>
            </c:extLst>
          </c:dPt>
          <c:dPt>
            <c:idx val="2"/>
            <c:invertIfNegative val="0"/>
            <c:bubble3D val="0"/>
            <c:spPr>
              <a:pattFill prst="dkDnDiag">
                <a:fgClr>
                  <a:srgbClr val="CC0099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BCB7-4BFF-B917-84B26A319889}"/>
              </c:ext>
            </c:extLst>
          </c:dPt>
          <c:dPt>
            <c:idx val="3"/>
            <c:invertIfNegative val="0"/>
            <c:bubble3D val="0"/>
            <c:spPr>
              <a:pattFill prst="dkDnDiag">
                <a:fgClr>
                  <a:srgbClr val="00CC33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BCB7-4BFF-B917-84B26A319889}"/>
              </c:ext>
            </c:extLst>
          </c:dPt>
          <c:dPt>
            <c:idx val="4"/>
            <c:invertIfNegative val="0"/>
            <c:bubble3D val="0"/>
            <c:spPr>
              <a:pattFill prst="dkDnDiag">
                <a:fgClr>
                  <a:srgbClr val="CC0099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E-BCB7-4BFF-B917-84B26A319889}"/>
              </c:ext>
            </c:extLst>
          </c:dPt>
          <c:dPt>
            <c:idx val="5"/>
            <c:invertIfNegative val="0"/>
            <c:bubble3D val="0"/>
            <c:spPr>
              <a:pattFill prst="dkDnDiag">
                <a:fgClr>
                  <a:srgbClr val="00CC33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0-BCB7-4BFF-B917-84B26A319889}"/>
              </c:ext>
            </c:extLst>
          </c:dPt>
          <c:dPt>
            <c:idx val="6"/>
            <c:invertIfNegative val="0"/>
            <c:bubble3D val="0"/>
            <c:spPr>
              <a:pattFill prst="dkDnDiag">
                <a:fgClr>
                  <a:srgbClr val="CC0099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2-BCB7-4BFF-B917-84B26A319889}"/>
              </c:ext>
            </c:extLst>
          </c:dPt>
          <c:dPt>
            <c:idx val="7"/>
            <c:invertIfNegative val="0"/>
            <c:bubble3D val="0"/>
            <c:spPr>
              <a:pattFill prst="dkDnDiag">
                <a:fgClr>
                  <a:srgbClr val="00CC33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4-BCB7-4BFF-B917-84B26A319889}"/>
              </c:ext>
            </c:extLst>
          </c:dPt>
          <c:dPt>
            <c:idx val="8"/>
            <c:invertIfNegative val="0"/>
            <c:bubble3D val="0"/>
            <c:spPr>
              <a:pattFill prst="dkDnDiag">
                <a:fgClr>
                  <a:srgbClr val="CC0099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6-BCB7-4BFF-B917-84B26A319889}"/>
              </c:ext>
            </c:extLst>
          </c:dPt>
          <c:dPt>
            <c:idx val="9"/>
            <c:invertIfNegative val="0"/>
            <c:bubble3D val="0"/>
            <c:spPr>
              <a:pattFill prst="dkDnDiag">
                <a:fgClr>
                  <a:srgbClr val="00CC33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8-BCB7-4BFF-B917-84B26A319889}"/>
              </c:ext>
            </c:extLst>
          </c:dPt>
          <c:errBars>
            <c:errBarType val="both"/>
            <c:errValType val="cust"/>
            <c:noEndCap val="0"/>
            <c:plus>
              <c:numRef>
                <c:f>('EIN1 (2)'!$F$61:$F$64,'EIN1 (2)'!$F$67:$F$72)</c:f>
                <c:numCache>
                  <c:formatCode>General</c:formatCode>
                  <c:ptCount val="10"/>
                  <c:pt idx="0">
                    <c:v>0.23553721102572608</c:v>
                  </c:pt>
                  <c:pt idx="1">
                    <c:v>0.23553721102572608</c:v>
                  </c:pt>
                  <c:pt idx="2">
                    <c:v>0.49487372126634616</c:v>
                  </c:pt>
                  <c:pt idx="3">
                    <c:v>0.49487372126634493</c:v>
                  </c:pt>
                  <c:pt idx="4">
                    <c:v>0.28085187871505846</c:v>
                  </c:pt>
                  <c:pt idx="5">
                    <c:v>0.28085187871505846</c:v>
                  </c:pt>
                  <c:pt idx="6">
                    <c:v>7.264831572567669E-2</c:v>
                  </c:pt>
                  <c:pt idx="7">
                    <c:v>7.2648315725676954E-2</c:v>
                  </c:pt>
                  <c:pt idx="8">
                    <c:v>5.4873592110513764E-2</c:v>
                  </c:pt>
                  <c:pt idx="9">
                    <c:v>5.4873592110513771E-2</c:v>
                  </c:pt>
                </c:numCache>
                <c:extLst/>
              </c:numRef>
            </c:plus>
            <c:minus>
              <c:numRef>
                <c:f>('EIN1 (2)'!$F$61:$F$64,'EIN1 (2)'!$F$67:$F$72)</c:f>
                <c:numCache>
                  <c:formatCode>General</c:formatCode>
                  <c:ptCount val="10"/>
                  <c:pt idx="0">
                    <c:v>0.23553721102572608</c:v>
                  </c:pt>
                  <c:pt idx="1">
                    <c:v>0.23553721102572608</c:v>
                  </c:pt>
                  <c:pt idx="2">
                    <c:v>0.49487372126634616</c:v>
                  </c:pt>
                  <c:pt idx="3">
                    <c:v>0.49487372126634493</c:v>
                  </c:pt>
                  <c:pt idx="4">
                    <c:v>0.28085187871505846</c:v>
                  </c:pt>
                  <c:pt idx="5">
                    <c:v>0.28085187871505846</c:v>
                  </c:pt>
                  <c:pt idx="6">
                    <c:v>7.264831572567669E-2</c:v>
                  </c:pt>
                  <c:pt idx="7">
                    <c:v>7.2648315725676954E-2</c:v>
                  </c:pt>
                  <c:pt idx="8">
                    <c:v>5.4873592110513764E-2</c:v>
                  </c:pt>
                  <c:pt idx="9">
                    <c:v>5.4873592110513771E-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EIN1 (2)'!$A$5:$A$6,'EIN1 (2)'!$A$11:$A$12,'EIN1 (2)'!$A$23:$A$24,'EIN1 (2)'!$A$29:$A$30,'EIN1 (2)'!$A$35:$A$36)</c:f>
              <c:strCache>
                <c:ptCount val="9"/>
                <c:pt idx="0">
                  <c:v>CpACS27</c:v>
                </c:pt>
                <c:pt idx="2">
                  <c:v>CpACS11</c:v>
                </c:pt>
                <c:pt idx="4">
                  <c:v>CpACO2</c:v>
                </c:pt>
                <c:pt idx="6">
                  <c:v>CpETR1A</c:v>
                </c:pt>
                <c:pt idx="8">
                  <c:v>CpETR1B</c:v>
                </c:pt>
              </c:strCache>
              <c:extLst/>
            </c:strRef>
          </c:cat>
          <c:val>
            <c:numRef>
              <c:f>('EIN1 (2)'!$D$5:$D$6,'EIN1 (2)'!$D$11:$D$12,'EIN1 (2)'!$D$23:$D$24,'EIN1 (2)'!$D$29:$D$30,'EIN1 (2)'!$D$35:$D$36)</c:f>
              <c:numCache>
                <c:formatCode>General</c:formatCode>
                <c:ptCount val="10"/>
                <c:pt idx="0">
                  <c:v>6.4733333333333318</c:v>
                </c:pt>
                <c:pt idx="1">
                  <c:v>5.9466666666666663</c:v>
                </c:pt>
                <c:pt idx="2">
                  <c:v>6.5033333333333312</c:v>
                </c:pt>
                <c:pt idx="3">
                  <c:v>4.1466666666666629</c:v>
                </c:pt>
                <c:pt idx="4">
                  <c:v>2.8133333333333317</c:v>
                </c:pt>
                <c:pt idx="5">
                  <c:v>1.8133333333333308</c:v>
                </c:pt>
                <c:pt idx="6" formatCode="0.00">
                  <c:v>0.72999999999999965</c:v>
                </c:pt>
                <c:pt idx="7" formatCode="0.00">
                  <c:v>0.36999999999999933</c:v>
                </c:pt>
                <c:pt idx="8">
                  <c:v>0.82666666666666699</c:v>
                </c:pt>
                <c:pt idx="9">
                  <c:v>0.3399999999999997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29-BCB7-4BFF-B917-84B26A3198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10894543"/>
        <c:axId val="257693855"/>
      </c:barChart>
      <c:catAx>
        <c:axId val="17108945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57693855"/>
        <c:crosses val="autoZero"/>
        <c:auto val="1"/>
        <c:lblAlgn val="ctr"/>
        <c:lblOffset val="100"/>
        <c:noMultiLvlLbl val="0"/>
      </c:catAx>
      <c:valAx>
        <c:axId val="257693855"/>
        <c:scaling>
          <c:orientation val="minMax"/>
          <c:min val="0"/>
        </c:scaling>
        <c:delete val="0"/>
        <c:axPos val="l"/>
        <c:numFmt formatCode="General" sourceLinked="1"/>
        <c:majorTickMark val="cross"/>
        <c:minorTickMark val="cross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17108945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4.9892858870028096E-2"/>
                  <c:y val="0.50664579970981893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105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s-ES"/>
                      <a:t> </a:t>
                    </a: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s-ES"/>
                </a:p>
              </c:txPr>
            </c:trendlineLbl>
          </c:trendline>
          <c:trendline>
            <c:spPr>
              <a:ln w="19050" cap="rnd">
                <a:solidFill>
                  <a:srgbClr val="000000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5.8917810730401234E-2"/>
                  <c:y val="-7.5577905921611094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s-ES"/>
                </a:p>
              </c:txPr>
            </c:trendlineLbl>
          </c:trendline>
          <c:xVal>
            <c:numRef>
              <c:f>'EIN1 (2)'!$AA$68:$AA$78</c:f>
              <c:numCache>
                <c:formatCode>General</c:formatCode>
                <c:ptCount val="11"/>
                <c:pt idx="0">
                  <c:v>6.4733333333333318</c:v>
                </c:pt>
                <c:pt idx="1">
                  <c:v>5.9466666666666663</c:v>
                </c:pt>
                <c:pt idx="2">
                  <c:v>6.5033333333333312</c:v>
                </c:pt>
                <c:pt idx="3">
                  <c:v>4.1466666666666629</c:v>
                </c:pt>
                <c:pt idx="4">
                  <c:v>1.0033333333333341</c:v>
                </c:pt>
                <c:pt idx="5">
                  <c:v>0.26666666666666583</c:v>
                </c:pt>
                <c:pt idx="6" formatCode="0.00">
                  <c:v>2.8133333333333317</c:v>
                </c:pt>
                <c:pt idx="7">
                  <c:v>1.8133333333333308</c:v>
                </c:pt>
                <c:pt idx="8">
                  <c:v>0.72999999999999965</c:v>
                </c:pt>
                <c:pt idx="9">
                  <c:v>0.36999999999999933</c:v>
                </c:pt>
                <c:pt idx="10">
                  <c:v>0.82666666666666699</c:v>
                </c:pt>
              </c:numCache>
            </c:numRef>
          </c:xVal>
          <c:yVal>
            <c:numRef>
              <c:f>'EIN1 (2)'!$AB$68:$AB$78</c:f>
              <c:numCache>
                <c:formatCode>General</c:formatCode>
                <c:ptCount val="11"/>
                <c:pt idx="0">
                  <c:v>5.2100007140059104</c:v>
                </c:pt>
                <c:pt idx="1">
                  <c:v>7.1621553194839196</c:v>
                </c:pt>
                <c:pt idx="2">
                  <c:v>8.6990391708771906</c:v>
                </c:pt>
                <c:pt idx="3">
                  <c:v>6.0576962494249802</c:v>
                </c:pt>
                <c:pt idx="4">
                  <c:v>-0.332186262900177</c:v>
                </c:pt>
                <c:pt idx="5">
                  <c:v>-0.50680070181113701</c:v>
                </c:pt>
                <c:pt idx="6">
                  <c:v>1.4015698040812199</c:v>
                </c:pt>
                <c:pt idx="7">
                  <c:v>1.5980133966591299</c:v>
                </c:pt>
                <c:pt idx="8">
                  <c:v>0.25706822707766602</c:v>
                </c:pt>
                <c:pt idx="9">
                  <c:v>0.113360716450782</c:v>
                </c:pt>
                <c:pt idx="10">
                  <c:v>0.3543525266861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D0A-4B53-8143-625456CA3B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4641064"/>
        <c:axId val="444633848"/>
      </c:scatterChart>
      <c:valAx>
        <c:axId val="44464106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/>
                  <a:t>qRT-PCR Log2_FC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444633848"/>
        <c:crosses val="autoZero"/>
        <c:crossBetween val="midCat"/>
      </c:valAx>
      <c:valAx>
        <c:axId val="4446338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/>
                  <a:t>RNA-seq Log2_FC</a:t>
                </a:r>
              </a:p>
            </c:rich>
          </c:tx>
          <c:layout>
            <c:manualLayout>
              <c:xMode val="edge"/>
              <c:yMode val="edge"/>
              <c:x val="6.7001675041876048E-3"/>
              <c:y val="0.1990371855691951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4446410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de título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texto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vertical y texto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y objetos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cabezado de sección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os objetos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ció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el título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n blanco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ido con título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n con título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o 4">
            <a:extLst>
              <a:ext uri="{FF2B5EF4-FFF2-40B4-BE49-F238E27FC236}">
                <a16:creationId xmlns:a16="http://schemas.microsoft.com/office/drawing/2014/main" id="{BD0B5AAD-5013-EE84-FEF2-613153885143}"/>
              </a:ext>
            </a:extLst>
          </p:cNvPr>
          <p:cNvGrpSpPr/>
          <p:nvPr/>
        </p:nvGrpSpPr>
        <p:grpSpPr>
          <a:xfrm>
            <a:off x="636825" y="1384279"/>
            <a:ext cx="5697300" cy="2346998"/>
            <a:chOff x="398700" y="1384279"/>
            <a:chExt cx="5697300" cy="2346998"/>
          </a:xfrm>
        </p:grpSpPr>
        <p:graphicFrame>
          <p:nvGraphicFramePr>
            <p:cNvPr id="85" name="Google Shape;85;p1"/>
            <p:cNvGraphicFramePr/>
            <p:nvPr>
              <p:extLst>
                <p:ext uri="{D42A27DB-BD31-4B8C-83A1-F6EECF244321}">
                  <p14:modId xmlns:p14="http://schemas.microsoft.com/office/powerpoint/2010/main" val="2396146085"/>
                </p:ext>
              </p:extLst>
            </p:nvPr>
          </p:nvGraphicFramePr>
          <p:xfrm>
            <a:off x="398700" y="1384279"/>
            <a:ext cx="5697300" cy="23311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6" name="Google Shape;86;p1"/>
            <p:cNvSpPr txBox="1"/>
            <p:nvPr/>
          </p:nvSpPr>
          <p:spPr>
            <a:xfrm>
              <a:off x="775067" y="3469707"/>
              <a:ext cx="929666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b="0" i="1" u="none" strike="noStrike" cap="none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pACS27A</a:t>
              </a:r>
              <a:endParaRPr sz="1100" dirty="0"/>
            </a:p>
          </p:txBody>
        </p:sp>
        <p:sp>
          <p:nvSpPr>
            <p:cNvPr id="87" name="Google Shape;87;p1"/>
            <p:cNvSpPr txBox="1"/>
            <p:nvPr/>
          </p:nvSpPr>
          <p:spPr>
            <a:xfrm>
              <a:off x="1923030" y="3469707"/>
              <a:ext cx="853313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i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pACS11</a:t>
              </a:r>
              <a:endParaRPr sz="1100"/>
            </a:p>
          </p:txBody>
        </p:sp>
        <p:sp>
          <p:nvSpPr>
            <p:cNvPr id="88" name="Google Shape;88;p1"/>
            <p:cNvSpPr txBox="1"/>
            <p:nvPr/>
          </p:nvSpPr>
          <p:spPr>
            <a:xfrm>
              <a:off x="2994639" y="3469707"/>
              <a:ext cx="929666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i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pACO2A</a:t>
              </a:r>
              <a:endParaRPr sz="1100"/>
            </a:p>
          </p:txBody>
        </p:sp>
        <p:sp>
          <p:nvSpPr>
            <p:cNvPr id="89" name="Google Shape;89;p1"/>
            <p:cNvSpPr txBox="1"/>
            <p:nvPr/>
          </p:nvSpPr>
          <p:spPr>
            <a:xfrm>
              <a:off x="4142602" y="3469707"/>
              <a:ext cx="853313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i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pETR1A</a:t>
              </a:r>
              <a:endParaRPr sz="1100"/>
            </a:p>
          </p:txBody>
        </p:sp>
        <p:sp>
          <p:nvSpPr>
            <p:cNvPr id="90" name="Google Shape;90;p1"/>
            <p:cNvSpPr txBox="1"/>
            <p:nvPr/>
          </p:nvSpPr>
          <p:spPr>
            <a:xfrm>
              <a:off x="5214213" y="3469707"/>
              <a:ext cx="853313" cy="2615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100" i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CpETR1B</a:t>
              </a:r>
              <a:endParaRPr sz="1100" dirty="0"/>
            </a:p>
          </p:txBody>
        </p:sp>
        <p:sp>
          <p:nvSpPr>
            <p:cNvPr id="92" name="Google Shape;92;p1"/>
            <p:cNvSpPr txBox="1"/>
            <p:nvPr/>
          </p:nvSpPr>
          <p:spPr>
            <a:xfrm>
              <a:off x="3207223" y="1421603"/>
              <a:ext cx="2449302" cy="147728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1_WT vs M0_WT </a:t>
              </a:r>
              <a:r>
                <a:rPr lang="en-US" sz="1000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NAseq</a:t>
              </a: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data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1_WT vs M0_WT </a:t>
              </a:r>
              <a:r>
                <a:rPr lang="en-US" sz="1000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qRT</a:t>
              </a: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PCR data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1_WT vs M1_</a:t>
              </a:r>
              <a:r>
                <a:rPr lang="en-US" sz="1000" i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etr1b</a:t>
              </a: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r>
                <a:rPr lang="en-US" sz="1000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RNAseq</a:t>
              </a: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data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M1_WT vs M1_</a:t>
              </a:r>
              <a:r>
                <a:rPr lang="en-US" sz="1000" i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etr1b</a:t>
              </a: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</a:t>
              </a:r>
              <a:r>
                <a:rPr lang="en-US" sz="1000" dirty="0" err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qRT</a:t>
              </a:r>
              <a:r>
                <a:rPr lang="en-US" sz="1000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PCR data</a:t>
              </a:r>
              <a:endParaRPr dirty="0"/>
            </a:p>
            <a:p>
              <a:pPr marL="0" marR="0" lvl="0" indent="0" algn="l" rtl="0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  <a:p>
              <a:pPr marL="0" marR="0" lvl="0" indent="0" algn="l" rtl="0">
                <a:lnSpc>
                  <a:spcPct val="15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3" name="Google Shape;93;p1"/>
            <p:cNvSpPr/>
            <p:nvPr/>
          </p:nvSpPr>
          <p:spPr>
            <a:xfrm>
              <a:off x="3115106" y="1515890"/>
              <a:ext cx="92117" cy="175823"/>
            </a:xfrm>
            <a:prstGeom prst="rect">
              <a:avLst/>
            </a:prstGeom>
            <a:solidFill>
              <a:srgbClr val="CC0099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24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4" name="Google Shape;94;p1"/>
            <p:cNvSpPr/>
            <p:nvPr/>
          </p:nvSpPr>
          <p:spPr>
            <a:xfrm>
              <a:off x="3115105" y="1731022"/>
              <a:ext cx="92117" cy="175823"/>
            </a:xfrm>
            <a:prstGeom prst="rect">
              <a:avLst/>
            </a:prstGeom>
            <a:pattFill prst="dkDnDiag">
              <a:fgClr>
                <a:srgbClr val="CC0099"/>
              </a:fgClr>
              <a:bgClr>
                <a:schemeClr val="bg1"/>
              </a:bgClr>
            </a:patt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24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5" name="Google Shape;95;p1"/>
            <p:cNvSpPr/>
            <p:nvPr/>
          </p:nvSpPr>
          <p:spPr>
            <a:xfrm>
              <a:off x="3115106" y="1955679"/>
              <a:ext cx="92117" cy="175823"/>
            </a:xfrm>
            <a:prstGeom prst="rect">
              <a:avLst/>
            </a:prstGeom>
            <a:solidFill>
              <a:srgbClr val="00CC33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24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6" name="Google Shape;96;p1"/>
            <p:cNvSpPr/>
            <p:nvPr/>
          </p:nvSpPr>
          <p:spPr>
            <a:xfrm>
              <a:off x="3115104" y="2180335"/>
              <a:ext cx="92117" cy="175823"/>
            </a:xfrm>
            <a:prstGeom prst="rect">
              <a:avLst/>
            </a:prstGeom>
            <a:pattFill prst="dkDnDiag">
              <a:fgClr>
                <a:srgbClr val="00CC33"/>
              </a:fgClr>
              <a:bgClr>
                <a:schemeClr val="bg1"/>
              </a:bgClr>
            </a:patt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240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97" name="Google Shape;97;p1"/>
          <p:cNvSpPr txBox="1"/>
          <p:nvPr/>
        </p:nvSpPr>
        <p:spPr>
          <a:xfrm>
            <a:off x="636825" y="4137866"/>
            <a:ext cx="10345500" cy="6001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1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Figure S1</a:t>
            </a:r>
            <a:r>
              <a:rPr lang="en-US" sz="1100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: RNA-seq validation. </a:t>
            </a:r>
            <a:r>
              <a:rPr lang="en-US" sz="1100" b="1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(A) </a:t>
            </a:r>
            <a:r>
              <a:rPr lang="en-US" sz="1100" b="0" i="0" u="none" strike="noStrike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Comparison of the relative expression of 5 biosynthesis and signaling genes by using RNA-seq and </a:t>
            </a:r>
            <a:r>
              <a:rPr lang="en-US" sz="1100" b="0" i="0" u="none" strike="noStrike" dirty="0" err="1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qRT</a:t>
            </a:r>
            <a:r>
              <a:rPr lang="en-US" sz="1100" b="0" i="0" u="none" strike="noStrike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-PCR in the apical shoots of WT and </a:t>
            </a:r>
            <a:r>
              <a:rPr lang="en-US" sz="1100" b="0" i="1" u="none" strike="noStrike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etr1b</a:t>
            </a:r>
            <a:r>
              <a:rPr lang="en-US" sz="1100" b="0" i="0" u="none" strike="noStrike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 mutant plants. Data represent log_2_FC of M1-WT vs M0-WT, and M1-WT vs M1-</a:t>
            </a:r>
            <a:r>
              <a:rPr lang="en-US" sz="1100" b="0" i="1" u="none" strike="noStrike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etr1b</a:t>
            </a:r>
            <a:r>
              <a:rPr lang="en-US" sz="1100" b="0" i="0" u="none" strike="noStrike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. Error bars represent standard error (SE). (B) Regression plot indicating the relationship between Log_2FC values from </a:t>
            </a:r>
            <a:r>
              <a:rPr lang="en-US" sz="1100" b="0" i="0" u="none" strike="noStrike" dirty="0" err="1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qRT</a:t>
            </a:r>
            <a:r>
              <a:rPr lang="en-US" sz="1100" b="0" i="0" u="none" strike="noStrike" dirty="0">
                <a:solidFill>
                  <a:srgbClr val="2E2E2E"/>
                </a:solidFill>
                <a:latin typeface="Arial"/>
                <a:ea typeface="Arial"/>
                <a:cs typeface="Arial"/>
                <a:sym typeface="Arial"/>
              </a:rPr>
              <a:t>-PCR and RNA-seq data in X and Y axes, respectively.</a:t>
            </a:r>
            <a:endParaRPr sz="11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id="{BFFD1288-DB9F-423B-AB18-A391B4D035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7266630"/>
              </p:ext>
            </p:extLst>
          </p:nvPr>
        </p:nvGraphicFramePr>
        <p:xfrm>
          <a:off x="7384972" y="1198563"/>
          <a:ext cx="3491428" cy="28440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CuadroTexto 1">
            <a:extLst>
              <a:ext uri="{FF2B5EF4-FFF2-40B4-BE49-F238E27FC236}">
                <a16:creationId xmlns:a16="http://schemas.microsoft.com/office/drawing/2014/main" id="{E491B175-F23A-48F8-5D4D-871D84776F26}"/>
              </a:ext>
            </a:extLst>
          </p:cNvPr>
          <p:cNvSpPr txBox="1"/>
          <p:nvPr/>
        </p:nvSpPr>
        <p:spPr>
          <a:xfrm>
            <a:off x="538480" y="984790"/>
            <a:ext cx="223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A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3DE1C5AB-9346-0F1E-98C7-4D21CE2F6051}"/>
              </a:ext>
            </a:extLst>
          </p:cNvPr>
          <p:cNvSpPr txBox="1"/>
          <p:nvPr/>
        </p:nvSpPr>
        <p:spPr>
          <a:xfrm>
            <a:off x="6981827" y="984790"/>
            <a:ext cx="223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38</Words>
  <Application>Microsoft Office PowerPoint</Application>
  <PresentationFormat>Panorámica</PresentationFormat>
  <Paragraphs>14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Segura Morales</dc:creator>
  <cp:lastModifiedBy>Maria Segura Morales</cp:lastModifiedBy>
  <cp:revision>3</cp:revision>
  <dcterms:created xsi:type="dcterms:W3CDTF">2023-10-05T07:36:59Z</dcterms:created>
  <dcterms:modified xsi:type="dcterms:W3CDTF">2023-12-05T17:07:47Z</dcterms:modified>
</cp:coreProperties>
</file>